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2.png" ContentType="image/png"/>
  <Override PartName="/ppt/media/image3.png" ContentType="image/png"/>
  <Override PartName="/ppt/media/image4.jpeg" ContentType="image/jpe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AFE6A3-97D4-447A-B8D7-EF018440C7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9E466-37A2-4020-8F42-422B677448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0A5F2-2E8E-481F-AB5D-54E0B4301F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015C6-0455-42B7-B9EC-D7BBE342A9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2BD90-C4C9-452A-B5A4-046E27756E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48722-7675-4A70-88AF-1BE9D3B163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7C4FAC-C958-4FAF-A5C0-E867564377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D67483-76C1-4D9A-8F8D-539437FE2E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B4707-7A1C-4AE8-BF23-A90D97E322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A7890-2467-4FB4-9A11-3E690F194E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14228-A72A-4715-B657-38C5FB8724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2FC9F0-5D5A-4A5E-AE97-0B36AF90D8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7CD40B-3CC4-4646-BDE8-8ECBDF65F9D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147080" y="6284880"/>
            <a:ext cx="183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0" t="0" r="125305" b="0"/>
          <a:stretch/>
        </p:blipFill>
        <p:spPr>
          <a:xfrm>
            <a:off x="2235240" y="123840"/>
            <a:ext cx="3278160" cy="6581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1195560" y="822240"/>
            <a:ext cx="6603840" cy="107964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2"/>
          <a:stretch/>
        </p:blipFill>
        <p:spPr>
          <a:xfrm>
            <a:off x="996840" y="2273400"/>
            <a:ext cx="6978600" cy="373212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860760" y="4557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860760" y="16416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147080" y="6284880"/>
            <a:ext cx="183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1616040" y="1415880"/>
            <a:ext cx="5159520" cy="3695760"/>
            <a:chOff x="1616040" y="1415880"/>
            <a:chExt cx="5159520" cy="3695760"/>
          </a:xfrm>
        </p:grpSpPr>
        <p:grpSp>
          <p:nvGrpSpPr>
            <p:cNvPr id="49" name=""/>
            <p:cNvGrpSpPr/>
            <p:nvPr/>
          </p:nvGrpSpPr>
          <p:grpSpPr>
            <a:xfrm>
              <a:off x="2940120" y="1415880"/>
              <a:ext cx="3835440" cy="3695760"/>
              <a:chOff x="2940120" y="1415880"/>
              <a:chExt cx="3835440" cy="3695760"/>
            </a:xfrm>
          </p:grpSpPr>
          <p:pic>
            <p:nvPicPr>
              <p:cNvPr id="50" name="" descr=""/>
              <p:cNvPicPr/>
              <p:nvPr/>
            </p:nvPicPr>
            <p:blipFill>
              <a:blip r:embed="rId1"/>
              <a:srcRect l="3768" t="0" r="19092" b="0"/>
              <a:stretch/>
            </p:blipFill>
            <p:spPr>
              <a:xfrm>
                <a:off x="2940120" y="1415880"/>
                <a:ext cx="3835440" cy="3695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1" name=""/>
              <p:cNvSpPr/>
              <p:nvPr/>
            </p:nvSpPr>
            <p:spPr>
              <a:xfrm>
                <a:off x="3281400" y="163044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800" spc="-1" strike="noStrike">
                    <a:solidFill>
                      <a:srgbClr val="ffffff"/>
                    </a:solidFill>
                    <a:latin typeface="Arial"/>
                  </a:rPr>
                  <a:t>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834000" y="163044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800" spc="-1" strike="noStrike">
                    <a:solidFill>
                      <a:srgbClr val="ffffff"/>
                    </a:solidFill>
                    <a:latin typeface="Arial"/>
                  </a:rPr>
                  <a:t>P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399200" y="163044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800" spc="-1" strike="noStrike">
                    <a:solidFill>
                      <a:srgbClr val="ffffff"/>
                    </a:solidFill>
                    <a:latin typeface="Arial"/>
                  </a:rPr>
                  <a:t>X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916880" y="1630440"/>
                <a:ext cx="345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800" spc="-1" strike="noStrike">
                    <a:solidFill>
                      <a:srgbClr val="ffffff"/>
                    </a:solidFill>
                    <a:latin typeface="Arial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5465880" y="163044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800" spc="-1" strike="noStrike">
                    <a:solidFill>
                      <a:srgbClr val="ffffff"/>
                    </a:solidFill>
                    <a:latin typeface="Arial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5986440" y="1630440"/>
                <a:ext cx="4856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800" spc="-1" strike="noStrike">
                    <a:solidFill>
                      <a:srgbClr val="ffffff"/>
                    </a:solidFill>
                    <a:latin typeface="Arial"/>
                  </a:rPr>
                  <a:t>XP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7" name=""/>
            <p:cNvSpPr/>
            <p:nvPr/>
          </p:nvSpPr>
          <p:spPr>
            <a:xfrm>
              <a:off x="2502000" y="2590920"/>
              <a:ext cx="33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502000" y="4102200"/>
              <a:ext cx="33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502000" y="3137040"/>
              <a:ext cx="330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616040" y="3949560"/>
              <a:ext cx="668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0,7 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720080" y="2984400"/>
              <a:ext cx="51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2 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720080" y="2438280"/>
              <a:ext cx="51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400" spc="-1" strike="noStrike">
                  <a:solidFill>
                    <a:srgbClr val="000000"/>
                  </a:solidFill>
                  <a:latin typeface="Arial"/>
                </a:rPr>
                <a:t>4 k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"/>
          <p:cNvSpPr/>
          <p:nvPr/>
        </p:nvSpPr>
        <p:spPr>
          <a:xfrm>
            <a:off x="7147080" y="6284880"/>
            <a:ext cx="183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"/>
          <p:cNvGrpSpPr/>
          <p:nvPr/>
        </p:nvGrpSpPr>
        <p:grpSpPr>
          <a:xfrm>
            <a:off x="1192320" y="1430280"/>
            <a:ext cx="2624040" cy="4073400"/>
            <a:chOff x="1192320" y="1430280"/>
            <a:chExt cx="2624040" cy="4073400"/>
          </a:xfrm>
        </p:grpSpPr>
        <p:pic>
          <p:nvPicPr>
            <p:cNvPr id="65" name="" descr=""/>
            <p:cNvPicPr/>
            <p:nvPr/>
          </p:nvPicPr>
          <p:blipFill>
            <a:blip r:embed="rId1"/>
            <a:stretch/>
          </p:blipFill>
          <p:spPr>
            <a:xfrm>
              <a:off x="1192320" y="1430280"/>
              <a:ext cx="2624040" cy="407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"/>
            <p:cNvSpPr/>
            <p:nvPr/>
          </p:nvSpPr>
          <p:spPr>
            <a:xfrm>
              <a:off x="3354120" y="143028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871720" y="143028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471400" y="143028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020680" y="143028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020680" y="217152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624040" y="306216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020680" y="306216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412640" y="306216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020680" y="4033800"/>
              <a:ext cx="2448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807640" y="4876920"/>
              <a:ext cx="308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268000" y="4876920"/>
              <a:ext cx="308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709280" y="4876920"/>
              <a:ext cx="308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"/>
          <p:cNvSpPr/>
          <p:nvPr/>
        </p:nvSpPr>
        <p:spPr>
          <a:xfrm>
            <a:off x="3774600" y="1419120"/>
            <a:ext cx="5789160" cy="386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: Dynein light</a:t>
            </a: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  <a:ea typeface="ＭＳ Ｐゴシック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ha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, 5, 6, 7, 9 &amp; 13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  <a:ea typeface="ＭＳ Ｐゴシック"/>
              </a:rPr>
              <a:t>similar (2,5 e-05) to T07C4.10 gen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coiled-coil protein necessary for transport from ER to Golgi; required for assembly of th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R-to-Golgi SNARE complex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,10: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imilar (2,9 e-08) to bath-4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Meprin like protein. TRAF domain: TNF receptor-associated factor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: No similarit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8: E3 ubiquitin ligas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1: Huntingtin interacting protei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2: No similarit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7147080" y="6284880"/>
            <a:ext cx="183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13T09:01:17Z</dcterms:created>
  <dc:creator>mpi</dc:creator>
  <dc:description/>
  <dc:language>en-US</dc:language>
  <cp:lastModifiedBy>mpi mpi</cp:lastModifiedBy>
  <dcterms:modified xsi:type="dcterms:W3CDTF">2007-08-20T08:27:13Z</dcterms:modified>
  <cp:revision>20</cp:revision>
  <dc:subject/>
  <dc:title>Slide 1</dc:title>
</cp:coreProperties>
</file>